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BCBCB"/>
    <a:srgbClr val="75DBFF"/>
    <a:srgbClr val="FF8585"/>
    <a:srgbClr val="CDACE6"/>
    <a:srgbClr val="71FFB1"/>
    <a:srgbClr val="FABEEF"/>
    <a:srgbClr val="FFEFBD"/>
    <a:srgbClr val="BEBEBE"/>
    <a:srgbClr val="3FCDFF"/>
    <a:srgbClr val="FF75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8" autoAdjust="0"/>
    <p:restoredTop sz="94660"/>
  </p:normalViewPr>
  <p:slideViewPr>
    <p:cSldViewPr snapToGrid="0">
      <p:cViewPr varScale="1">
        <p:scale>
          <a:sx n="69" d="100"/>
          <a:sy n="69" d="100"/>
        </p:scale>
        <p:origin x="3344" y="23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c\Downloads\table%20georges%20(1)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c\Downloads\table%20georges%20(1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c\Downloads\table%20georges%20(1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c\Downloads\table%20georges%20(1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table georges (1).xlsx]Sheet2'!$C$9</c:f>
              <c:strCache>
                <c:ptCount val="1"/>
                <c:pt idx="0">
                  <c:v>PVS Debri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B$10:$B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C$10:$C$11</c:f>
              <c:numCache>
                <c:formatCode>0.00%</c:formatCode>
                <c:ptCount val="2"/>
                <c:pt idx="0">
                  <c:v>0.78400000000000003</c:v>
                </c:pt>
                <c:pt idx="1">
                  <c:v>0.706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AD-40AB-9C7E-BFC6F12E121B}"/>
            </c:ext>
          </c:extLst>
        </c:ser>
        <c:ser>
          <c:idx val="1"/>
          <c:order val="1"/>
          <c:tx>
            <c:strRef>
              <c:f>'[table georges (1).xlsx]Sheet2'!$D$9</c:f>
              <c:strCache>
                <c:ptCount val="1"/>
                <c:pt idx="0">
                  <c:v>No PVS Debri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5.8330112399406171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1CD-431D-9E24-21644FC9FE09}"/>
                </c:ext>
              </c:extLst>
            </c:dLbl>
            <c:dLbl>
              <c:idx val="1"/>
              <c:layout>
                <c:manualLayout>
                  <c:x val="4.4869317230312442E-2"/>
                  <c:y val="-7.5668609622068063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1CD-431D-9E24-21644FC9FE0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B$10:$B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D$10:$D$11</c:f>
              <c:numCache>
                <c:formatCode>0.00%</c:formatCode>
                <c:ptCount val="2"/>
                <c:pt idx="0">
                  <c:v>0.216</c:v>
                </c:pt>
                <c:pt idx="1">
                  <c:v>0.292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AD-40AB-9C7E-BFC6F12E12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569984"/>
        <c:axId val="134571520"/>
      </c:barChart>
      <c:catAx>
        <c:axId val="134569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34571520"/>
        <c:crosses val="autoZero"/>
        <c:auto val="1"/>
        <c:lblAlgn val="ctr"/>
        <c:lblOffset val="100"/>
        <c:noMultiLvlLbl val="0"/>
      </c:catAx>
      <c:valAx>
        <c:axId val="134571520"/>
        <c:scaling>
          <c:orientation val="minMax"/>
          <c:max val="1"/>
          <c:min val="0"/>
        </c:scaling>
        <c:delete val="0"/>
        <c:axPos val="l"/>
        <c:numFmt formatCode="0.0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34569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table georges (1).xlsx]Sheet2'!$H$9</c:f>
              <c:strCache>
                <c:ptCount val="1"/>
                <c:pt idx="0">
                  <c:v>Fragmented PB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Lbl>
              <c:idx val="1"/>
              <c:layout>
                <c:manualLayout>
                  <c:x val="0"/>
                  <c:y val="1.202556284578459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DAA3-4FE7-AC3D-52DC9953219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[table georges (1).xlsx]Sheet2'!$G$10:$G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H$10:$H$11</c:f>
              <c:numCache>
                <c:formatCode>0.00%</c:formatCode>
                <c:ptCount val="2"/>
                <c:pt idx="0">
                  <c:v>0.24</c:v>
                </c:pt>
                <c:pt idx="1">
                  <c:v>0.383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3AA-45C3-97DE-BBEC6A1069A8}"/>
            </c:ext>
          </c:extLst>
        </c:ser>
        <c:ser>
          <c:idx val="1"/>
          <c:order val="1"/>
          <c:tx>
            <c:strRef>
              <c:f>'[table georges (1).xlsx]Sheet2'!$I$9</c:f>
              <c:strCache>
                <c:ptCount val="1"/>
                <c:pt idx="0">
                  <c:v>Not Fragmented PB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G$10:$G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I$10:$I$11</c:f>
              <c:numCache>
                <c:formatCode>0.00%</c:formatCode>
                <c:ptCount val="2"/>
                <c:pt idx="0">
                  <c:v>0.76</c:v>
                </c:pt>
                <c:pt idx="1">
                  <c:v>0.616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3AA-45C3-97DE-BBEC6A1069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5007616"/>
        <c:axId val="135013504"/>
      </c:barChart>
      <c:catAx>
        <c:axId val="135007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35013504"/>
        <c:crosses val="autoZero"/>
        <c:auto val="1"/>
        <c:lblAlgn val="ctr"/>
        <c:lblOffset val="100"/>
        <c:noMultiLvlLbl val="0"/>
      </c:catAx>
      <c:valAx>
        <c:axId val="135013504"/>
        <c:scaling>
          <c:orientation val="minMax"/>
        </c:scaling>
        <c:delete val="0"/>
        <c:axPos val="l"/>
        <c:numFmt formatCode="0.0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350076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table georges (1).xlsx]Sheet2'!$N$9</c:f>
              <c:strCache>
                <c:ptCount val="1"/>
                <c:pt idx="0">
                  <c:v>Central granularit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M$10:$M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N$10:$N$11</c:f>
              <c:numCache>
                <c:formatCode>0.00%</c:formatCode>
                <c:ptCount val="2"/>
                <c:pt idx="0">
                  <c:v>6.0999999999999999E-2</c:v>
                </c:pt>
                <c:pt idx="1">
                  <c:v>9.0999999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1C-40EB-A159-C6CB3901C2AC}"/>
            </c:ext>
          </c:extLst>
        </c:ser>
        <c:ser>
          <c:idx val="1"/>
          <c:order val="1"/>
          <c:tx>
            <c:strRef>
              <c:f>'[table georges (1).xlsx]Sheet2'!$O$9</c:f>
              <c:strCache>
                <c:ptCount val="1"/>
                <c:pt idx="0">
                  <c:v>No central granularity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M$10:$M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O$10:$O$11</c:f>
              <c:numCache>
                <c:formatCode>0.00%</c:formatCode>
                <c:ptCount val="2"/>
                <c:pt idx="0">
                  <c:v>0.93899999999999995</c:v>
                </c:pt>
                <c:pt idx="1">
                  <c:v>0.909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1C-40EB-A159-C6CB3901C2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5044480"/>
        <c:axId val="135046272"/>
      </c:barChart>
      <c:catAx>
        <c:axId val="135044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35046272"/>
        <c:crosses val="autoZero"/>
        <c:auto val="1"/>
        <c:lblAlgn val="ctr"/>
        <c:lblOffset val="100"/>
        <c:noMultiLvlLbl val="0"/>
      </c:catAx>
      <c:valAx>
        <c:axId val="135046272"/>
        <c:scaling>
          <c:orientation val="minMax"/>
        </c:scaling>
        <c:delete val="0"/>
        <c:axPos val="l"/>
        <c:numFmt formatCode="0.0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35044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table georges (1).xlsx]Sheet2'!$S$9</c:f>
              <c:strCache>
                <c:ptCount val="1"/>
                <c:pt idx="0">
                  <c:v>Small Inclusi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R$10:$R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S$10:$S$11</c:f>
              <c:numCache>
                <c:formatCode>0.00%</c:formatCode>
                <c:ptCount val="2"/>
                <c:pt idx="0">
                  <c:v>0.83099999999999996</c:v>
                </c:pt>
                <c:pt idx="1">
                  <c:v>0.8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97-4783-B936-F9001CD4B1E2}"/>
            </c:ext>
          </c:extLst>
        </c:ser>
        <c:ser>
          <c:idx val="1"/>
          <c:order val="1"/>
          <c:tx>
            <c:strRef>
              <c:f>'[table georges (1).xlsx]Sheet2'!$T$9</c:f>
              <c:strCache>
                <c:ptCount val="1"/>
                <c:pt idx="0">
                  <c:v>No small Inclusion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R$10:$R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T$10:$T$11</c:f>
              <c:numCache>
                <c:formatCode>0.00%</c:formatCode>
                <c:ptCount val="2"/>
                <c:pt idx="0">
                  <c:v>0.16900000000000001</c:v>
                </c:pt>
                <c:pt idx="1">
                  <c:v>0.1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97-4783-B936-F9001CD4B1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0782592"/>
        <c:axId val="140792576"/>
      </c:barChart>
      <c:catAx>
        <c:axId val="140782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40792576"/>
        <c:crosses val="autoZero"/>
        <c:auto val="1"/>
        <c:lblAlgn val="ctr"/>
        <c:lblOffset val="100"/>
        <c:noMultiLvlLbl val="0"/>
      </c:catAx>
      <c:valAx>
        <c:axId val="140792576"/>
        <c:scaling>
          <c:orientation val="minMax"/>
        </c:scaling>
        <c:delete val="0"/>
        <c:axPos val="l"/>
        <c:numFmt formatCode="0.0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40782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table georges (1).xlsx]Sheet2'!$W$9</c:f>
              <c:strCache>
                <c:ptCount val="1"/>
                <c:pt idx="0">
                  <c:v>Small Vacuol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V$10:$V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W$10:$W$11</c:f>
              <c:numCache>
                <c:formatCode>0.00%</c:formatCode>
                <c:ptCount val="2"/>
                <c:pt idx="0">
                  <c:v>8.7999999999999995E-2</c:v>
                </c:pt>
                <c:pt idx="1">
                  <c:v>9.5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CF-42D2-8F9C-AB7B0307340E}"/>
            </c:ext>
          </c:extLst>
        </c:ser>
        <c:ser>
          <c:idx val="1"/>
          <c:order val="1"/>
          <c:tx>
            <c:strRef>
              <c:f>'[table georges (1).xlsx]Sheet2'!$X$9</c:f>
              <c:strCache>
                <c:ptCount val="1"/>
                <c:pt idx="0">
                  <c:v>No Small Vacuole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table georges (1).xlsx]Sheet2'!$V$10:$V$11</c:f>
              <c:strCache>
                <c:ptCount val="2"/>
                <c:pt idx="0">
                  <c:v>Fertilized</c:v>
                </c:pt>
                <c:pt idx="1">
                  <c:v>Not Fertilized</c:v>
                </c:pt>
              </c:strCache>
            </c:strRef>
          </c:cat>
          <c:val>
            <c:numRef>
              <c:f>'[table georges (1).xlsx]Sheet2'!$X$10:$X$11</c:f>
              <c:numCache>
                <c:formatCode>0.00%</c:formatCode>
                <c:ptCount val="2"/>
                <c:pt idx="0">
                  <c:v>0.91200000000000003</c:v>
                </c:pt>
                <c:pt idx="1">
                  <c:v>0.905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CF-42D2-8F9C-AB7B030734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0831360"/>
        <c:axId val="139542912"/>
      </c:barChart>
      <c:catAx>
        <c:axId val="140831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39542912"/>
        <c:crosses val="autoZero"/>
        <c:auto val="1"/>
        <c:lblAlgn val="ctr"/>
        <c:lblOffset val="100"/>
        <c:noMultiLvlLbl val="0"/>
      </c:catAx>
      <c:valAx>
        <c:axId val="139542912"/>
        <c:scaling>
          <c:orientation val="minMax"/>
        </c:scaling>
        <c:delete val="0"/>
        <c:axPos val="l"/>
        <c:numFmt formatCode="0.0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18" charset="0"/>
                <a:ea typeface="+mn-ea"/>
                <a:cs typeface="+mn-cs"/>
              </a:defRPr>
            </a:pPr>
            <a:endParaRPr lang="en-US"/>
          </a:p>
        </c:txPr>
        <c:crossAx val="1408313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6508</cdr:x>
      <cdr:y>0.17335</cdr:y>
    </cdr:from>
    <cdr:to>
      <cdr:x>0.75851</cdr:x>
      <cdr:y>0.3005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3668F15F-DCFB-142D-E006-B6260CC4E550}"/>
            </a:ext>
          </a:extLst>
        </cdr:cNvPr>
        <cdr:cNvSpPr txBox="1"/>
      </cdr:nvSpPr>
      <cdr:spPr>
        <a:xfrm xmlns:a="http://schemas.openxmlformats.org/drawingml/2006/main">
          <a:off x="2326453" y="305029"/>
          <a:ext cx="326837" cy="2238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400" b="1" dirty="0">
              <a:solidFill>
                <a:srgbClr val="FF0000"/>
              </a:solidFill>
              <a:latin typeface="Times" pitchFamily="18" charset="0"/>
            </a:rPr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195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047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815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85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106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17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67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237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708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828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569EBD-2979-452B-A450-9B232A5A244A}" type="datetimeFigureOut">
              <a:rPr lang="en-US" smtClean="0"/>
              <a:t>12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F5F666-CD18-4928-8631-C586C44534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459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554C319-5287-C2D3-DD0D-F5F12B0ECF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7726820"/>
              </p:ext>
            </p:extLst>
          </p:nvPr>
        </p:nvGraphicFramePr>
        <p:xfrm>
          <a:off x="1827489" y="714868"/>
          <a:ext cx="2830442" cy="1678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 rot="16200000">
            <a:off x="601202" y="1230887"/>
            <a:ext cx="17139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" pitchFamily="18" charset="0"/>
              </a:rPr>
              <a:t>Presence of debris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In the PVS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(%)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D94F796-119F-3AE4-BEA2-326AE5F34A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8124408"/>
              </p:ext>
            </p:extLst>
          </p:nvPr>
        </p:nvGraphicFramePr>
        <p:xfrm>
          <a:off x="1930360" y="2755043"/>
          <a:ext cx="3110484" cy="1575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587325" y="3197722"/>
            <a:ext cx="17139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" pitchFamily="18" charset="0"/>
              </a:rPr>
              <a:t>Fragmented PBI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(%)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6D088865-46EA-9A81-AECB-027FD73DA1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2558387"/>
              </p:ext>
            </p:extLst>
          </p:nvPr>
        </p:nvGraphicFramePr>
        <p:xfrm>
          <a:off x="1852007" y="4546354"/>
          <a:ext cx="3188837" cy="1715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 rot="16200000">
            <a:off x="580605" y="5017078"/>
            <a:ext cx="17139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" pitchFamily="18" charset="0"/>
              </a:rPr>
              <a:t>Presence of central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granularity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(%)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77A04394-E173-FF95-D1EC-6AFD719C60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1388300"/>
              </p:ext>
            </p:extLst>
          </p:nvPr>
        </p:nvGraphicFramePr>
        <p:xfrm>
          <a:off x="1930360" y="6591494"/>
          <a:ext cx="3164839" cy="18239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TextBox 8"/>
          <p:cNvSpPr txBox="1"/>
          <p:nvPr/>
        </p:nvSpPr>
        <p:spPr>
          <a:xfrm rot="16200000">
            <a:off x="400136" y="7127723"/>
            <a:ext cx="19825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" pitchFamily="18" charset="0"/>
              </a:rPr>
              <a:t>Presence of small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Cytoplasmic inclusions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(%)</a:t>
            </a: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78E85A37-124A-F1E2-C0D2-8B44924783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1174078"/>
              </p:ext>
            </p:extLst>
          </p:nvPr>
        </p:nvGraphicFramePr>
        <p:xfrm>
          <a:off x="1930360" y="8744609"/>
          <a:ext cx="3116838" cy="1739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1" name="TextBox 10"/>
          <p:cNvSpPr txBox="1"/>
          <p:nvPr/>
        </p:nvSpPr>
        <p:spPr>
          <a:xfrm rot="16200000">
            <a:off x="450877" y="9236312"/>
            <a:ext cx="18484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" pitchFamily="18" charset="0"/>
              </a:rPr>
              <a:t>Presence of small 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Cytoplasmic vacuoles</a:t>
            </a:r>
          </a:p>
          <a:p>
            <a:pPr algn="ctr"/>
            <a:r>
              <a:rPr lang="en-US" sz="1200" b="1" dirty="0">
                <a:latin typeface="Times" pitchFamily="18" charset="0"/>
              </a:rPr>
              <a:t>(%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61172" y="10703527"/>
            <a:ext cx="70745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" pitchFamily="18" charset="0"/>
              </a:rPr>
              <a:t>Supplementary figure 1: The impact of debris in the PVS, PBI fragmentation, and cytoplasmic dysmorphisms on fertilisation rate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69DA77D-57E4-4078-A3FE-7C2E149536E5}"/>
              </a:ext>
            </a:extLst>
          </p:cNvPr>
          <p:cNvSpPr/>
          <p:nvPr/>
        </p:nvSpPr>
        <p:spPr>
          <a:xfrm>
            <a:off x="5095199" y="1026808"/>
            <a:ext cx="261257" cy="20682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FA1BA93-63D8-4C21-8146-D66988698214}"/>
              </a:ext>
            </a:extLst>
          </p:cNvPr>
          <p:cNvSpPr txBox="1"/>
          <p:nvPr/>
        </p:nvSpPr>
        <p:spPr>
          <a:xfrm>
            <a:off x="5432656" y="899389"/>
            <a:ext cx="9688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 debris in the PV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602D99F-FF13-4177-B893-388FD3D303EC}"/>
              </a:ext>
            </a:extLst>
          </p:cNvPr>
          <p:cNvSpPr/>
          <p:nvPr/>
        </p:nvSpPr>
        <p:spPr>
          <a:xfrm>
            <a:off x="5127853" y="1571100"/>
            <a:ext cx="261257" cy="20682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E68ECE8-7067-4BB0-B5A1-B079B914E167}"/>
              </a:ext>
            </a:extLst>
          </p:cNvPr>
          <p:cNvSpPr txBox="1"/>
          <p:nvPr/>
        </p:nvSpPr>
        <p:spPr>
          <a:xfrm>
            <a:off x="5465310" y="1400133"/>
            <a:ext cx="9688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out debris in the PV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EF133C0-4083-47D4-8FC3-8ACCAB96E85F}"/>
              </a:ext>
            </a:extLst>
          </p:cNvPr>
          <p:cNvSpPr/>
          <p:nvPr/>
        </p:nvSpPr>
        <p:spPr>
          <a:xfrm>
            <a:off x="5106087" y="2920914"/>
            <a:ext cx="261257" cy="20682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CB64380-C8C1-4F69-BB8E-F8E92C7B4365}"/>
              </a:ext>
            </a:extLst>
          </p:cNvPr>
          <p:cNvSpPr txBox="1"/>
          <p:nvPr/>
        </p:nvSpPr>
        <p:spPr>
          <a:xfrm>
            <a:off x="5443544" y="2793495"/>
            <a:ext cx="11974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Fragmented </a:t>
            </a:r>
          </a:p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PBI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4414813-52E9-4099-8DAC-04037719EB89}"/>
              </a:ext>
            </a:extLst>
          </p:cNvPr>
          <p:cNvSpPr/>
          <p:nvPr/>
        </p:nvSpPr>
        <p:spPr>
          <a:xfrm>
            <a:off x="5138741" y="3465206"/>
            <a:ext cx="261257" cy="20682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DDFE512-E9B2-40DB-86D4-9624F5374DDE}"/>
              </a:ext>
            </a:extLst>
          </p:cNvPr>
          <p:cNvSpPr txBox="1"/>
          <p:nvPr/>
        </p:nvSpPr>
        <p:spPr>
          <a:xfrm>
            <a:off x="5443544" y="3457079"/>
            <a:ext cx="11974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Non-fragmented </a:t>
            </a:r>
          </a:p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PBI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AA1854B-F9B2-4DC0-8AF6-D2A8CD82C4F1}"/>
              </a:ext>
            </a:extLst>
          </p:cNvPr>
          <p:cNvSpPr/>
          <p:nvPr/>
        </p:nvSpPr>
        <p:spPr>
          <a:xfrm>
            <a:off x="5106087" y="4932594"/>
            <a:ext cx="261257" cy="20682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DAF0767-01DF-4CA3-B3F2-7443B56EA342}"/>
              </a:ext>
            </a:extLst>
          </p:cNvPr>
          <p:cNvSpPr txBox="1"/>
          <p:nvPr/>
        </p:nvSpPr>
        <p:spPr>
          <a:xfrm>
            <a:off x="5443544" y="4805175"/>
            <a:ext cx="11974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 central granularity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950501E1-2174-49F8-B439-A6D8256D4DB5}"/>
              </a:ext>
            </a:extLst>
          </p:cNvPr>
          <p:cNvSpPr/>
          <p:nvPr/>
        </p:nvSpPr>
        <p:spPr>
          <a:xfrm>
            <a:off x="5138741" y="5476886"/>
            <a:ext cx="261257" cy="20682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89D5E11-34DB-4364-A09A-D126B3FBA4EE}"/>
              </a:ext>
            </a:extLst>
          </p:cNvPr>
          <p:cNvSpPr txBox="1"/>
          <p:nvPr/>
        </p:nvSpPr>
        <p:spPr>
          <a:xfrm>
            <a:off x="5410477" y="5392249"/>
            <a:ext cx="11974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out central granularity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A72AE87-FC21-4071-8B8E-C80FE7698748}"/>
              </a:ext>
            </a:extLst>
          </p:cNvPr>
          <p:cNvSpPr/>
          <p:nvPr/>
        </p:nvSpPr>
        <p:spPr>
          <a:xfrm>
            <a:off x="5098467" y="7035714"/>
            <a:ext cx="261257" cy="20682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3911634-ACD2-4880-970F-28F6140A33FD}"/>
              </a:ext>
            </a:extLst>
          </p:cNvPr>
          <p:cNvSpPr txBox="1"/>
          <p:nvPr/>
        </p:nvSpPr>
        <p:spPr>
          <a:xfrm>
            <a:off x="5432656" y="6835436"/>
            <a:ext cx="11974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 small cytoplasmic inclusions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30B932E-79A3-4E4E-B1FC-66D0C8FB370B}"/>
              </a:ext>
            </a:extLst>
          </p:cNvPr>
          <p:cNvSpPr/>
          <p:nvPr/>
        </p:nvSpPr>
        <p:spPr>
          <a:xfrm>
            <a:off x="5131121" y="7580006"/>
            <a:ext cx="261257" cy="20682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DD39816-4C64-49FE-A4EB-808683AE4CB8}"/>
              </a:ext>
            </a:extLst>
          </p:cNvPr>
          <p:cNvSpPr txBox="1"/>
          <p:nvPr/>
        </p:nvSpPr>
        <p:spPr>
          <a:xfrm>
            <a:off x="5402857" y="7495369"/>
            <a:ext cx="11974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out small cytoplasmic inclusions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7E080928-782B-4D97-BFE3-211BF6C60EA9}"/>
              </a:ext>
            </a:extLst>
          </p:cNvPr>
          <p:cNvSpPr/>
          <p:nvPr/>
        </p:nvSpPr>
        <p:spPr>
          <a:xfrm>
            <a:off x="5106087" y="9100734"/>
            <a:ext cx="261257" cy="20682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0B9FDD0-08F0-4F92-BE62-D30D7EF69479}"/>
              </a:ext>
            </a:extLst>
          </p:cNvPr>
          <p:cNvSpPr txBox="1"/>
          <p:nvPr/>
        </p:nvSpPr>
        <p:spPr>
          <a:xfrm>
            <a:off x="5440276" y="8900456"/>
            <a:ext cx="11974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 small cytoplasmic vacuoles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1A51286-7BB1-4A90-B457-AACB94BB4678}"/>
              </a:ext>
            </a:extLst>
          </p:cNvPr>
          <p:cNvSpPr/>
          <p:nvPr/>
        </p:nvSpPr>
        <p:spPr>
          <a:xfrm>
            <a:off x="5138741" y="9645026"/>
            <a:ext cx="261257" cy="20682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70C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604D594-B844-4D47-A6DE-52315D708907}"/>
              </a:ext>
            </a:extLst>
          </p:cNvPr>
          <p:cNvSpPr txBox="1"/>
          <p:nvPr/>
        </p:nvSpPr>
        <p:spPr>
          <a:xfrm>
            <a:off x="5410477" y="9560389"/>
            <a:ext cx="11974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Without small cytoplasmic vacuole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A5C75B7-8404-4407-B2AA-2CCBABC4128B}"/>
              </a:ext>
            </a:extLst>
          </p:cNvPr>
          <p:cNvSpPr txBox="1"/>
          <p:nvPr/>
        </p:nvSpPr>
        <p:spPr>
          <a:xfrm>
            <a:off x="457200" y="457200"/>
            <a:ext cx="355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4CF3881-D7C4-4DA0-B8A7-F63A1C109245}"/>
              </a:ext>
            </a:extLst>
          </p:cNvPr>
          <p:cNvSpPr txBox="1"/>
          <p:nvPr/>
        </p:nvSpPr>
        <p:spPr>
          <a:xfrm>
            <a:off x="431800" y="2693180"/>
            <a:ext cx="355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1022F17-7C57-4D98-B78C-719893939E5B}"/>
              </a:ext>
            </a:extLst>
          </p:cNvPr>
          <p:cNvSpPr txBox="1"/>
          <p:nvPr/>
        </p:nvSpPr>
        <p:spPr>
          <a:xfrm>
            <a:off x="457200" y="4862424"/>
            <a:ext cx="355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69CD22B-ACAA-4BB2-8B16-B56934BE443C}"/>
              </a:ext>
            </a:extLst>
          </p:cNvPr>
          <p:cNvSpPr txBox="1"/>
          <p:nvPr/>
        </p:nvSpPr>
        <p:spPr>
          <a:xfrm>
            <a:off x="431800" y="6754669"/>
            <a:ext cx="355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D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71322F3-0B85-401C-86A7-D0D76969281A}"/>
              </a:ext>
            </a:extLst>
          </p:cNvPr>
          <p:cNvSpPr txBox="1"/>
          <p:nvPr/>
        </p:nvSpPr>
        <p:spPr>
          <a:xfrm>
            <a:off x="401059" y="8927149"/>
            <a:ext cx="355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" panose="02020603050405020304" pitchFamily="18" charset="0"/>
                <a:cs typeface="Times" panose="02020603050405020304" pitchFamily="18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902873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7</TotalTime>
  <Words>93</Words>
  <Application>Microsoft Macintosh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c</dc:creator>
  <cp:lastModifiedBy>George Liperis</cp:lastModifiedBy>
  <cp:revision>48</cp:revision>
  <dcterms:created xsi:type="dcterms:W3CDTF">2023-05-10T05:37:07Z</dcterms:created>
  <dcterms:modified xsi:type="dcterms:W3CDTF">2023-12-03T06:08:06Z</dcterms:modified>
</cp:coreProperties>
</file>